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6" userDrawn="1">
          <p15:clr>
            <a:srgbClr val="A4A3A4"/>
          </p15:clr>
        </p15:guide>
        <p15:guide id="2" pos="2137" userDrawn="1">
          <p15:clr>
            <a:srgbClr val="A4A3A4"/>
          </p15:clr>
        </p15:guide>
        <p15:guide id="3" orient="horz" pos="207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863"/>
    <p:restoredTop sz="94624"/>
  </p:normalViewPr>
  <p:slideViewPr>
    <p:cSldViewPr snapToGrid="0" snapToObjects="1" showGuides="1">
      <p:cViewPr>
        <p:scale>
          <a:sx n="132" d="100"/>
          <a:sy n="132" d="100"/>
        </p:scale>
        <p:origin x="1496" y="-272"/>
      </p:cViewPr>
      <p:guideLst>
        <p:guide orient="horz" pos="3846"/>
        <p:guide pos="2137"/>
        <p:guide orient="horz" pos="207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B41F56-30D6-CE4B-BB24-2F083BB67FFB}" type="datetimeFigureOut">
              <a:rPr lang="en-US" smtClean="0"/>
              <a:t>10/3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268026-596A-B04E-8B9D-377043C5A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7997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B980B-684F-EC48-A3EB-3E836C2C3D06}" type="datetimeFigureOut">
              <a:rPr lang="en-US" smtClean="0"/>
              <a:t>10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0696C-3DD0-0F4C-AE30-3A5B11AE2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723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B980B-684F-EC48-A3EB-3E836C2C3D06}" type="datetimeFigureOut">
              <a:rPr lang="en-US" smtClean="0"/>
              <a:t>10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0696C-3DD0-0F4C-AE30-3A5B11AE2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50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B980B-684F-EC48-A3EB-3E836C2C3D06}" type="datetimeFigureOut">
              <a:rPr lang="en-US" smtClean="0"/>
              <a:t>10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0696C-3DD0-0F4C-AE30-3A5B11AE2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9391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B980B-684F-EC48-A3EB-3E836C2C3D06}" type="datetimeFigureOut">
              <a:rPr lang="en-US" smtClean="0"/>
              <a:t>10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0696C-3DD0-0F4C-AE30-3A5B11AE2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924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B980B-684F-EC48-A3EB-3E836C2C3D06}" type="datetimeFigureOut">
              <a:rPr lang="en-US" smtClean="0"/>
              <a:t>10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0696C-3DD0-0F4C-AE30-3A5B11AE2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2422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B980B-684F-EC48-A3EB-3E836C2C3D06}" type="datetimeFigureOut">
              <a:rPr lang="en-US" smtClean="0"/>
              <a:t>10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0696C-3DD0-0F4C-AE30-3A5B11AE2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0298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B980B-684F-EC48-A3EB-3E836C2C3D06}" type="datetimeFigureOut">
              <a:rPr lang="en-US" smtClean="0"/>
              <a:t>10/3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0696C-3DD0-0F4C-AE30-3A5B11AE2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4967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B980B-684F-EC48-A3EB-3E836C2C3D06}" type="datetimeFigureOut">
              <a:rPr lang="en-US" smtClean="0"/>
              <a:t>10/3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0696C-3DD0-0F4C-AE30-3A5B11AE2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4372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B980B-684F-EC48-A3EB-3E836C2C3D06}" type="datetimeFigureOut">
              <a:rPr lang="en-US" smtClean="0"/>
              <a:t>10/3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0696C-3DD0-0F4C-AE30-3A5B11AE2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445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B980B-684F-EC48-A3EB-3E836C2C3D06}" type="datetimeFigureOut">
              <a:rPr lang="en-US" smtClean="0"/>
              <a:t>10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0696C-3DD0-0F4C-AE30-3A5B11AE2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087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B980B-684F-EC48-A3EB-3E836C2C3D06}" type="datetimeFigureOut">
              <a:rPr lang="en-US" smtClean="0"/>
              <a:t>10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0696C-3DD0-0F4C-AE30-3A5B11AE2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519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8B980B-684F-EC48-A3EB-3E836C2C3D06}" type="datetimeFigureOut">
              <a:rPr lang="en-US" smtClean="0"/>
              <a:t>10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40696C-3DD0-0F4C-AE30-3A5B11AE21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6247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Picture 32">
            <a:extLst>
              <a:ext uri="{FF2B5EF4-FFF2-40B4-BE49-F238E27FC236}">
                <a16:creationId xmlns:a16="http://schemas.microsoft.com/office/drawing/2014/main" id="{C71D4D03-B620-824D-BD9B-BE6FA5654E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1787" y="934127"/>
            <a:ext cx="1039800" cy="10584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588DBC5-87B3-9D47-B145-57608F7042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90195" y="986820"/>
            <a:ext cx="1152636" cy="1020572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DE17E7E8-5BFE-164C-9E72-C14704F8B65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8042" y="927776"/>
            <a:ext cx="1087422" cy="106200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E3F753D3-BC29-BE49-9E6D-3F87A17B029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48388" y="918916"/>
            <a:ext cx="1065793" cy="1080000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1C506603-CCE4-784F-8410-64368EB546DA}"/>
              </a:ext>
            </a:extLst>
          </p:cNvPr>
          <p:cNvSpPr txBox="1"/>
          <p:nvPr/>
        </p:nvSpPr>
        <p:spPr>
          <a:xfrm>
            <a:off x="765676" y="1934118"/>
            <a:ext cx="35957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FEF98E7-D100-ED4D-9C66-A659A9C49F95}"/>
              </a:ext>
            </a:extLst>
          </p:cNvPr>
          <p:cNvSpPr txBox="1"/>
          <p:nvPr/>
        </p:nvSpPr>
        <p:spPr>
          <a:xfrm rot="16200000">
            <a:off x="486570" y="1637079"/>
            <a:ext cx="426805" cy="2013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5C80C903-4438-2347-8524-D98B1E48A992}"/>
              </a:ext>
            </a:extLst>
          </p:cNvPr>
          <p:cNvCxnSpPr>
            <a:cxnSpLocks/>
          </p:cNvCxnSpPr>
          <p:nvPr/>
        </p:nvCxnSpPr>
        <p:spPr>
          <a:xfrm>
            <a:off x="1098028" y="2038917"/>
            <a:ext cx="632428" cy="0"/>
          </a:xfrm>
          <a:prstGeom prst="straightConnector1">
            <a:avLst/>
          </a:prstGeom>
          <a:ln w="12700">
            <a:tailEnd type="triangle" w="sm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34E9FD38-DB97-8248-81FD-FC5F5A092749}"/>
              </a:ext>
            </a:extLst>
          </p:cNvPr>
          <p:cNvCxnSpPr>
            <a:cxnSpLocks/>
          </p:cNvCxnSpPr>
          <p:nvPr/>
        </p:nvCxnSpPr>
        <p:spPr>
          <a:xfrm flipV="1">
            <a:off x="696197" y="980076"/>
            <a:ext cx="0" cy="612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EF5C03C8-FEAC-0941-93B9-18F323C19ACA}"/>
              </a:ext>
            </a:extLst>
          </p:cNvPr>
          <p:cNvCxnSpPr>
            <a:cxnSpLocks/>
          </p:cNvCxnSpPr>
          <p:nvPr/>
        </p:nvCxnSpPr>
        <p:spPr>
          <a:xfrm flipV="1">
            <a:off x="1924833" y="986820"/>
            <a:ext cx="0" cy="612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3063285A-5686-8843-813A-037C1CF3F368}"/>
              </a:ext>
            </a:extLst>
          </p:cNvPr>
          <p:cNvSpPr txBox="1"/>
          <p:nvPr/>
        </p:nvSpPr>
        <p:spPr>
          <a:xfrm rot="16200000">
            <a:off x="1725647" y="1640775"/>
            <a:ext cx="426805" cy="2013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6521E06-0957-0843-856F-976A341CE458}"/>
              </a:ext>
            </a:extLst>
          </p:cNvPr>
          <p:cNvSpPr txBox="1"/>
          <p:nvPr/>
        </p:nvSpPr>
        <p:spPr>
          <a:xfrm>
            <a:off x="2018061" y="1934118"/>
            <a:ext cx="4632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6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A4B93BF9-79DF-1744-8538-5CE2659DC98A}"/>
              </a:ext>
            </a:extLst>
          </p:cNvPr>
          <p:cNvCxnSpPr>
            <a:cxnSpLocks/>
          </p:cNvCxnSpPr>
          <p:nvPr/>
        </p:nvCxnSpPr>
        <p:spPr>
          <a:xfrm>
            <a:off x="2382782" y="2038917"/>
            <a:ext cx="584308" cy="0"/>
          </a:xfrm>
          <a:prstGeom prst="straightConnector1">
            <a:avLst/>
          </a:prstGeom>
          <a:ln w="12700">
            <a:tailEnd type="triangle" w="sm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70A205EB-2207-D149-B716-BCD1F4F0B7C9}"/>
              </a:ext>
            </a:extLst>
          </p:cNvPr>
          <p:cNvSpPr txBox="1"/>
          <p:nvPr/>
        </p:nvSpPr>
        <p:spPr>
          <a:xfrm>
            <a:off x="3237075" y="1934118"/>
            <a:ext cx="5200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KG2D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4197FB06-E78A-BC4A-8453-7414B1D02A1C}"/>
              </a:ext>
            </a:extLst>
          </p:cNvPr>
          <p:cNvCxnSpPr>
            <a:cxnSpLocks/>
          </p:cNvCxnSpPr>
          <p:nvPr/>
        </p:nvCxnSpPr>
        <p:spPr>
          <a:xfrm>
            <a:off x="3690808" y="2038917"/>
            <a:ext cx="515566" cy="0"/>
          </a:xfrm>
          <a:prstGeom prst="straightConnector1">
            <a:avLst/>
          </a:prstGeom>
          <a:ln w="12700">
            <a:tailEnd type="triangle" w="sm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A5B2C676-D646-2941-88F6-6BC5A46F3253}"/>
              </a:ext>
            </a:extLst>
          </p:cNvPr>
          <p:cNvCxnSpPr>
            <a:cxnSpLocks/>
          </p:cNvCxnSpPr>
          <p:nvPr/>
        </p:nvCxnSpPr>
        <p:spPr>
          <a:xfrm flipV="1">
            <a:off x="3145377" y="985472"/>
            <a:ext cx="0" cy="612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DB9390E3-299B-F349-A3F0-9550B7A50DF2}"/>
              </a:ext>
            </a:extLst>
          </p:cNvPr>
          <p:cNvSpPr txBox="1"/>
          <p:nvPr/>
        </p:nvSpPr>
        <p:spPr>
          <a:xfrm rot="16200000">
            <a:off x="2946191" y="1639427"/>
            <a:ext cx="426805" cy="2013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C1D207E-195C-B545-BF72-E9DE3D17B84B}"/>
              </a:ext>
            </a:extLst>
          </p:cNvPr>
          <p:cNvSpPr txBox="1"/>
          <p:nvPr/>
        </p:nvSpPr>
        <p:spPr>
          <a:xfrm>
            <a:off x="4833361" y="2004651"/>
            <a:ext cx="35957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0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85832F2-F65C-054C-8CAA-A55120DA7524}"/>
              </a:ext>
            </a:extLst>
          </p:cNvPr>
          <p:cNvSpPr txBox="1"/>
          <p:nvPr/>
        </p:nvSpPr>
        <p:spPr>
          <a:xfrm>
            <a:off x="5145211" y="2004651"/>
            <a:ext cx="61500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7</a:t>
            </a:r>
            <a:r>
              <a: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14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B535D67-D4FB-4D44-8B9D-A1D7B1F3D727}"/>
              </a:ext>
            </a:extLst>
          </p:cNvPr>
          <p:cNvSpPr txBox="1"/>
          <p:nvPr/>
        </p:nvSpPr>
        <p:spPr>
          <a:xfrm rot="16200000">
            <a:off x="4045704" y="1425912"/>
            <a:ext cx="9143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K</a:t>
            </a:r>
            <a:r>
              <a: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ansion</a:t>
            </a:r>
            <a:r>
              <a:rPr lang="zh-CN" altLang="en-US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endParaRPr 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A79B009-6F16-4A41-BCFE-2E82D10A8520}"/>
              </a:ext>
            </a:extLst>
          </p:cNvPr>
          <p:cNvSpPr txBox="1"/>
          <p:nvPr/>
        </p:nvSpPr>
        <p:spPr>
          <a:xfrm>
            <a:off x="566816" y="726160"/>
            <a:ext cx="348602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zh-CN" alt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</a:t>
            </a:r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zh-CN" alt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</a:t>
            </a:r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CA5266D-4366-8D4C-A7BA-60DB8A3F803E}"/>
              </a:ext>
            </a:extLst>
          </p:cNvPr>
          <p:cNvSpPr txBox="1"/>
          <p:nvPr/>
        </p:nvSpPr>
        <p:spPr>
          <a:xfrm>
            <a:off x="4361653" y="732904"/>
            <a:ext cx="26966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1029B636-3AA4-9B4F-8D9C-977D3BC96C8B}"/>
              </a:ext>
            </a:extLst>
          </p:cNvPr>
          <p:cNvSpPr/>
          <p:nvPr/>
        </p:nvSpPr>
        <p:spPr>
          <a:xfrm>
            <a:off x="462309" y="2204839"/>
            <a:ext cx="586882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S1. K562 feeder cells induce dramatic NK cell expansion </a:t>
            </a:r>
            <a:r>
              <a:rPr lang="en-US" sz="1200" b="1" i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ex vivo</a:t>
            </a:r>
            <a:r>
              <a:rPr lang="en-US" sz="1200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K cells were expanded using irradiated K562 cells expressing mbIL15, mbIL-21 and 4-1BB ligand for 14 days in SCGM medium with addition of IL-2 (50IU/ml). (</a:t>
            </a:r>
            <a:r>
              <a:rPr lang="en-US" sz="1200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The purity of CD3</a:t>
            </a:r>
            <a:r>
              <a:rPr lang="en-US" sz="12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CD56</a:t>
            </a:r>
            <a:r>
              <a:rPr lang="en-US" sz="1200" baseline="300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NK cells. (</a:t>
            </a:r>
            <a:r>
              <a:rPr lang="en-US" sz="1200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CD16 expression of NK cells. (</a:t>
            </a:r>
            <a:r>
              <a:rPr lang="en-US" sz="1200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NKG2D expression of NK cells. (</a:t>
            </a:r>
            <a:r>
              <a:rPr lang="en-US" sz="1200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sz="12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NK cell expansion after day 7 and day 14 of culture. NK cell number was counted at D0, D7 and D14 and was normalized to D0. Data were presented as Mean ± SEM (n=8).</a:t>
            </a:r>
            <a:endParaRPr lang="en-SG" sz="12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96855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65</TotalTime>
  <Words>134</Words>
  <Application>Microsoft Macintosh PowerPoint</Application>
  <PresentationFormat>A4 Paper (210x297 mm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 zixi</dc:creator>
  <cp:lastModifiedBy>Wang zixi</cp:lastModifiedBy>
  <cp:revision>35</cp:revision>
  <dcterms:created xsi:type="dcterms:W3CDTF">2019-09-14T14:39:59Z</dcterms:created>
  <dcterms:modified xsi:type="dcterms:W3CDTF">2019-10-03T04:02:05Z</dcterms:modified>
</cp:coreProperties>
</file>